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78" r:id="rId2"/>
    <p:sldId id="279" r:id="rId3"/>
  </p:sldIdLst>
  <p:sldSz cx="12192000" cy="6858000"/>
  <p:notesSz cx="7102475" cy="93884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315" userDrawn="1">
          <p15:clr>
            <a:srgbClr val="A4A3A4"/>
          </p15:clr>
        </p15:guide>
        <p15:guide id="2" pos="3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9051"/>
    <a:srgbClr val="009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édio 2 - Destaqu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838" autoAdjust="0"/>
    <p:restoredTop sz="80988"/>
  </p:normalViewPr>
  <p:slideViewPr>
    <p:cSldViewPr snapToGrid="0" snapToObjects="1" showGuides="1">
      <p:cViewPr varScale="1">
        <p:scale>
          <a:sx n="114" d="100"/>
          <a:sy n="114" d="100"/>
        </p:scale>
        <p:origin x="480" y="108"/>
      </p:cViewPr>
      <p:guideLst>
        <p:guide orient="horz" pos="4315"/>
        <p:guide pos="3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hakraborty, Anirban" userId="beb374dd-c17a-4851-a293-48dd327a1c1a" providerId="ADAL" clId="{92EC0B4F-30CB-481F-BE55-57D4AE2F89C2}"/>
    <pc:docChg chg="undo custSel addSld delSld modSld">
      <pc:chgData name="Chakraborty, Anirban" userId="beb374dd-c17a-4851-a293-48dd327a1c1a" providerId="ADAL" clId="{92EC0B4F-30CB-481F-BE55-57D4AE2F89C2}" dt="2023-09-19T13:40:29.166" v="15" actId="20577"/>
      <pc:docMkLst>
        <pc:docMk/>
      </pc:docMkLst>
      <pc:sldChg chg="del">
        <pc:chgData name="Chakraborty, Anirban" userId="beb374dd-c17a-4851-a293-48dd327a1c1a" providerId="ADAL" clId="{92EC0B4F-30CB-481F-BE55-57D4AE2F89C2}" dt="2023-09-19T13:16:24.696" v="1" actId="47"/>
        <pc:sldMkLst>
          <pc:docMk/>
          <pc:sldMk cId="1499400212" sldId="270"/>
        </pc:sldMkLst>
      </pc:sldChg>
      <pc:sldChg chg="del">
        <pc:chgData name="Chakraborty, Anirban" userId="beb374dd-c17a-4851-a293-48dd327a1c1a" providerId="ADAL" clId="{92EC0B4F-30CB-481F-BE55-57D4AE2F89C2}" dt="2023-09-19T13:16:24.696" v="1" actId="47"/>
        <pc:sldMkLst>
          <pc:docMk/>
          <pc:sldMk cId="1362357393" sldId="271"/>
        </pc:sldMkLst>
      </pc:sldChg>
      <pc:sldChg chg="del">
        <pc:chgData name="Chakraborty, Anirban" userId="beb374dd-c17a-4851-a293-48dd327a1c1a" providerId="ADAL" clId="{92EC0B4F-30CB-481F-BE55-57D4AE2F89C2}" dt="2023-09-19T13:16:24.696" v="1" actId="47"/>
        <pc:sldMkLst>
          <pc:docMk/>
          <pc:sldMk cId="3109744734" sldId="272"/>
        </pc:sldMkLst>
      </pc:sldChg>
      <pc:sldChg chg="del">
        <pc:chgData name="Chakraborty, Anirban" userId="beb374dd-c17a-4851-a293-48dd327a1c1a" providerId="ADAL" clId="{92EC0B4F-30CB-481F-BE55-57D4AE2F89C2}" dt="2023-09-19T13:16:24.696" v="1" actId="47"/>
        <pc:sldMkLst>
          <pc:docMk/>
          <pc:sldMk cId="3096922174" sldId="274"/>
        </pc:sldMkLst>
      </pc:sldChg>
      <pc:sldChg chg="del">
        <pc:chgData name="Chakraborty, Anirban" userId="beb374dd-c17a-4851-a293-48dd327a1c1a" providerId="ADAL" clId="{92EC0B4F-30CB-481F-BE55-57D4AE2F89C2}" dt="2023-09-19T13:16:24.696" v="1" actId="47"/>
        <pc:sldMkLst>
          <pc:docMk/>
          <pc:sldMk cId="2573754816" sldId="276"/>
        </pc:sldMkLst>
      </pc:sldChg>
      <pc:sldChg chg="delSp mod">
        <pc:chgData name="Chakraborty, Anirban" userId="beb374dd-c17a-4851-a293-48dd327a1c1a" providerId="ADAL" clId="{92EC0B4F-30CB-481F-BE55-57D4AE2F89C2}" dt="2023-09-19T13:16:18.236" v="0" actId="478"/>
        <pc:sldMkLst>
          <pc:docMk/>
          <pc:sldMk cId="550479794" sldId="278"/>
        </pc:sldMkLst>
        <pc:spChg chg="del">
          <ac:chgData name="Chakraborty, Anirban" userId="beb374dd-c17a-4851-a293-48dd327a1c1a" providerId="ADAL" clId="{92EC0B4F-30CB-481F-BE55-57D4AE2F89C2}" dt="2023-09-19T13:16:18.236" v="0" actId="478"/>
          <ac:spMkLst>
            <pc:docMk/>
            <pc:sldMk cId="550479794" sldId="278"/>
            <ac:spMk id="2" creationId="{00000000-0000-0000-0000-000000000000}"/>
          </ac:spMkLst>
        </pc:spChg>
      </pc:sldChg>
      <pc:sldChg chg="modSp add del mod">
        <pc:chgData name="Chakraborty, Anirban" userId="beb374dd-c17a-4851-a293-48dd327a1c1a" providerId="ADAL" clId="{92EC0B4F-30CB-481F-BE55-57D4AE2F89C2}" dt="2023-09-19T13:40:29.166" v="15" actId="20577"/>
        <pc:sldMkLst>
          <pc:docMk/>
          <pc:sldMk cId="3002076954" sldId="279"/>
        </pc:sldMkLst>
        <pc:spChg chg="mod">
          <ac:chgData name="Chakraborty, Anirban" userId="beb374dd-c17a-4851-a293-48dd327a1c1a" providerId="ADAL" clId="{92EC0B4F-30CB-481F-BE55-57D4AE2F89C2}" dt="2023-09-19T13:40:29.166" v="15" actId="20577"/>
          <ac:spMkLst>
            <pc:docMk/>
            <pc:sldMk cId="3002076954" sldId="279"/>
            <ac:spMk id="13" creationId="{00000000-0000-0000-0000-000000000000}"/>
          </ac:spMkLst>
        </pc:spChg>
        <pc:spChg chg="mod">
          <ac:chgData name="Chakraborty, Anirban" userId="beb374dd-c17a-4851-a293-48dd327a1c1a" providerId="ADAL" clId="{92EC0B4F-30CB-481F-BE55-57D4AE2F89C2}" dt="2023-09-19T13:35:23.385" v="9" actId="1076"/>
          <ac:spMkLst>
            <pc:docMk/>
            <pc:sldMk cId="3002076954" sldId="279"/>
            <ac:spMk id="25" creationId="{00000000-0000-0000-0000-000000000000}"/>
          </ac:spMkLst>
        </pc:spChg>
        <pc:spChg chg="mod">
          <ac:chgData name="Chakraborty, Anirban" userId="beb374dd-c17a-4851-a293-48dd327a1c1a" providerId="ADAL" clId="{92EC0B4F-30CB-481F-BE55-57D4AE2F89C2}" dt="2023-09-19T13:35:14.683" v="8" actId="1037"/>
          <ac:spMkLst>
            <pc:docMk/>
            <pc:sldMk cId="3002076954" sldId="279"/>
            <ac:spMk id="54" creationId="{00000000-0000-0000-0000-000000000000}"/>
          </ac:spMkLst>
        </pc:spChg>
      </pc:sldChg>
      <pc:sldChg chg="add del">
        <pc:chgData name="Chakraborty, Anirban" userId="beb374dd-c17a-4851-a293-48dd327a1c1a" providerId="ADAL" clId="{92EC0B4F-30CB-481F-BE55-57D4AE2F89C2}" dt="2023-09-19T13:16:50.015" v="6" actId="47"/>
        <pc:sldMkLst>
          <pc:docMk/>
          <pc:sldMk cId="3852428335" sldId="280"/>
        </pc:sldMkLst>
      </pc:sldChg>
      <pc:sldChg chg="add del">
        <pc:chgData name="Chakraborty, Anirban" userId="beb374dd-c17a-4851-a293-48dd327a1c1a" providerId="ADAL" clId="{92EC0B4F-30CB-481F-BE55-57D4AE2F89C2}" dt="2023-09-19T13:16:50.015" v="6" actId="47"/>
        <pc:sldMkLst>
          <pc:docMk/>
          <pc:sldMk cId="1026364918" sldId="281"/>
        </pc:sldMkLst>
      </pc:sldChg>
      <pc:sldChg chg="add del">
        <pc:chgData name="Chakraborty, Anirban" userId="beb374dd-c17a-4851-a293-48dd327a1c1a" providerId="ADAL" clId="{92EC0B4F-30CB-481F-BE55-57D4AE2F89C2}" dt="2023-09-19T13:16:53.209" v="7" actId="47"/>
        <pc:sldMkLst>
          <pc:docMk/>
          <pc:sldMk cId="2329365240" sldId="282"/>
        </pc:sldMkLst>
      </pc:sldChg>
      <pc:sldChg chg="add del">
        <pc:chgData name="Chakraborty, Anirban" userId="beb374dd-c17a-4851-a293-48dd327a1c1a" providerId="ADAL" clId="{92EC0B4F-30CB-481F-BE55-57D4AE2F89C2}" dt="2023-09-19T13:16:53.209" v="7" actId="47"/>
        <pc:sldMkLst>
          <pc:docMk/>
          <pc:sldMk cId="438658365" sldId="284"/>
        </pc:sldMkLst>
      </pc:sldChg>
      <pc:sldChg chg="add del">
        <pc:chgData name="Chakraborty, Anirban" userId="beb374dd-c17a-4851-a293-48dd327a1c1a" providerId="ADAL" clId="{92EC0B4F-30CB-481F-BE55-57D4AE2F89C2}" dt="2023-09-19T13:16:50.015" v="6" actId="47"/>
        <pc:sldMkLst>
          <pc:docMk/>
          <pc:sldMk cId="1305156795" sldId="285"/>
        </pc:sldMkLst>
      </pc:sldChg>
      <pc:sldChg chg="add del">
        <pc:chgData name="Chakraborty, Anirban" userId="beb374dd-c17a-4851-a293-48dd327a1c1a" providerId="ADAL" clId="{92EC0B4F-30CB-481F-BE55-57D4AE2F89C2}" dt="2023-09-19T13:16:50.015" v="6" actId="47"/>
        <pc:sldMkLst>
          <pc:docMk/>
          <pc:sldMk cId="4028044274" sldId="286"/>
        </pc:sldMkLst>
      </pc:sldChg>
      <pc:sldChg chg="add del">
        <pc:chgData name="Chakraborty, Anirban" userId="beb374dd-c17a-4851-a293-48dd327a1c1a" providerId="ADAL" clId="{92EC0B4F-30CB-481F-BE55-57D4AE2F89C2}" dt="2023-09-19T13:16:53.209" v="7" actId="47"/>
        <pc:sldMkLst>
          <pc:docMk/>
          <pc:sldMk cId="256142667" sldId="287"/>
        </pc:sldMkLst>
      </pc:sldChg>
      <pc:sldChg chg="add del">
        <pc:chgData name="Chakraborty, Anirban" userId="beb374dd-c17a-4851-a293-48dd327a1c1a" providerId="ADAL" clId="{92EC0B4F-30CB-481F-BE55-57D4AE2F89C2}" dt="2023-09-19T13:16:53.209" v="7" actId="47"/>
        <pc:sldMkLst>
          <pc:docMk/>
          <pc:sldMk cId="3421195017" sldId="288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7739" cy="471054"/>
          </a:xfrm>
          <a:prstGeom prst="rect">
            <a:avLst/>
          </a:prstGeom>
        </p:spPr>
        <p:txBody>
          <a:bodyPr vert="horz" lIns="94229" tIns="47114" rIns="94229" bIns="47114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3092" y="0"/>
            <a:ext cx="3077739" cy="471054"/>
          </a:xfrm>
          <a:prstGeom prst="rect">
            <a:avLst/>
          </a:prstGeom>
        </p:spPr>
        <p:txBody>
          <a:bodyPr vert="horz" lIns="94229" tIns="47114" rIns="94229" bIns="47114" rtlCol="0"/>
          <a:lstStyle>
            <a:lvl1pPr algn="r">
              <a:defRPr sz="1200"/>
            </a:lvl1pPr>
          </a:lstStyle>
          <a:p>
            <a:fld id="{E8D3B8AE-E6A7-C943-834B-509E182B2575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35013" y="1173163"/>
            <a:ext cx="5632450" cy="31686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229" tIns="47114" rIns="94229" bIns="47114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10248" y="4518204"/>
            <a:ext cx="5681980" cy="3696712"/>
          </a:xfrm>
          <a:prstGeom prst="rect">
            <a:avLst/>
          </a:prstGeom>
        </p:spPr>
        <p:txBody>
          <a:bodyPr vert="horz" lIns="94229" tIns="47114" rIns="94229" bIns="47114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917422"/>
            <a:ext cx="3077739" cy="471053"/>
          </a:xfrm>
          <a:prstGeom prst="rect">
            <a:avLst/>
          </a:prstGeom>
        </p:spPr>
        <p:txBody>
          <a:bodyPr vert="horz" lIns="94229" tIns="47114" rIns="94229" bIns="47114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3092" y="8917422"/>
            <a:ext cx="3077739" cy="471053"/>
          </a:xfrm>
          <a:prstGeom prst="rect">
            <a:avLst/>
          </a:prstGeom>
        </p:spPr>
        <p:txBody>
          <a:bodyPr vert="horz" lIns="94229" tIns="47114" rIns="94229" bIns="47114" rtlCol="0" anchor="b"/>
          <a:lstStyle>
            <a:lvl1pPr algn="r">
              <a:defRPr sz="1200"/>
            </a:lvl1pPr>
          </a:lstStyle>
          <a:p>
            <a:fld id="{F048A57D-F6E1-034D-9BC0-9C2FC71C8D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22271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D2D4F7-2021-A642-B0CE-338B123010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7CCA26C-5B50-B94F-82D6-8760696C27C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986B55-454B-624D-A8D3-B1248D1B54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6245B3-23F0-9445-AE77-CA1A1FD8D7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06163F-C787-3142-915E-C391486175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12788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8E13B3-C6AC-5A43-9ACB-B4BA394C25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FB46718-2042-F04B-9FAD-3A485529EF6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14F6B8-0A0A-AE4D-A494-4C95AE6C02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95348F-7B1A-4B46-B822-6736B29385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53BCF7-4449-3A4E-B494-1AFC21D8A9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81826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7DFC63B-84F7-4243-A5B4-1EC304FD4F3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E4AB81E-D3C6-C94C-A282-3BF98AFCD16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F9AD0D-7288-654F-956C-AD2593D6F5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E14BA3-1568-7241-BDAB-8CA5920E1C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464E63-C144-C745-A366-8399D40202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85814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94461C-9762-2342-A51E-38E476E7CB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E624E9A-EA4E-1744-AF11-1D43DC789A3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EC2680-0E9C-3144-862B-AFB3E69D44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DA7B78-FC12-D747-AAC1-F9FAD2ADCF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8D220A-A23D-CA41-995A-E6A03A04E2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790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7078E1-7996-144E-B8D4-476A685625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0D34C9-D05D-1E49-84C5-6333390D51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706A32-BAB0-E645-8BDF-589DD81C4E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EABB79-D302-C944-A688-1B470D9DF7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C1689D-4A8C-8E46-82E9-B3534632DA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15900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D3BDA4-9FCB-EE4C-810C-5C5661A105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C51E0D0-4ABC-714F-89BF-8FCDBAE7463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A2CB25A-C5E7-D94D-B661-81D2A868C76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7377595-6DF1-794D-A232-1C9958EDDC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4239CD3-9B4C-504C-879A-B4107E76E5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AAA483B-07C6-2043-8671-5B808FCA03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80721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40A434-9C06-A042-A4F7-732F439847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A32AE10-BF72-0049-A0E4-F4BA1C9927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E8F7D1D-D036-B44B-9630-10A6978CF8F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FE2EEC0-124E-EC46-8D02-E81AD515A3A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FE4BCE2-4DE2-D24C-86A9-F1C6DF72495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C13A7F2-94A9-B349-9B3B-D0F826A3AB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FCC8104-22AE-3045-9A1A-2FA341AFA1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5E858AB-36F4-684B-A9FE-18BB4BC0E2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36508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6DAA0F-1B23-4344-A407-89B3D606D8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71CE5D9-E60A-9F46-8E26-6AB7D33989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5FD3E93-5CF8-F348-A2F5-35068A6A29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E692F73-EA23-F34A-B504-CD619EC2CC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52901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8F41EA2-0F06-6444-967C-B8D532FB39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70B9B18-2F70-1048-BBA6-F718B57021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2347B7B-3038-7141-BB16-7C04389F12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09671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91EAD8-56A1-5E41-B7CA-A0A401B027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E040C8-CB84-0B4E-88B3-B0C73BBC467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B122BAF-B99A-4E49-A59A-614A49394D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2F12B9D-5CAD-3A41-8FBA-DC8923E9AB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B1579BE-E6ED-F945-ABE3-80AAC0A4C7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7CED946-F4A8-C24C-A6DA-BD2627D6F1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09441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E022CB-3D02-1B4F-841E-DE018BDD64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2453081-0A59-1244-B45A-AA0D2D67F6C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34762F7-554D-E34C-A3DD-AE030B3D4E5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A46D7CA-F115-1B41-8DF9-AC61BF628A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5D61EFA-B3A1-C442-89E4-0AE9234490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5531CB6-9230-FB4A-84ED-FD6D385D0D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67802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BAF5F41-1579-A24F-A466-EE012090CD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8FAB8E2-733C-0C44-8972-CE6D7845E4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E5B314-1FC4-DC40-8D1B-57D2252FED3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DDC9C2-2FD4-D142-8295-6FFB674C282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299995-9E3D-E54E-A29C-ECE6B57766C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76621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15056" y="972312"/>
            <a:ext cx="5961888" cy="4913376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686425" y="66675"/>
            <a:ext cx="9048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. 2</a:t>
            </a:r>
          </a:p>
        </p:txBody>
      </p:sp>
      <p:sp>
        <p:nvSpPr>
          <p:cNvPr id="6" name="Rectangle 5"/>
          <p:cNvSpPr/>
          <p:nvPr/>
        </p:nvSpPr>
        <p:spPr>
          <a:xfrm>
            <a:off x="5686425" y="2845832"/>
            <a:ext cx="3533775" cy="318349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04797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5059662" y="72490"/>
            <a:ext cx="30483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Original uncropped Fig. 2D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21434" y="2880277"/>
            <a:ext cx="2719052" cy="2914141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1666843" y="3587844"/>
            <a:ext cx="1697275" cy="54376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TextBox 40"/>
          <p:cNvSpPr txBox="1"/>
          <p:nvPr/>
        </p:nvSpPr>
        <p:spPr>
          <a:xfrm>
            <a:off x="1676307" y="2496416"/>
            <a:ext cx="25431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    2    3     4    5</a:t>
            </a:r>
          </a:p>
        </p:txBody>
      </p:sp>
      <p:sp>
        <p:nvSpPr>
          <p:cNvPr id="43" name="TextBox 42"/>
          <p:cNvSpPr txBox="1"/>
          <p:nvPr/>
        </p:nvSpPr>
        <p:spPr>
          <a:xfrm rot="16200000">
            <a:off x="1456161" y="1948400"/>
            <a:ext cx="8096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ST</a:t>
            </a:r>
          </a:p>
        </p:txBody>
      </p:sp>
      <p:sp>
        <p:nvSpPr>
          <p:cNvPr id="44" name="TextBox 43"/>
          <p:cNvSpPr txBox="1"/>
          <p:nvPr/>
        </p:nvSpPr>
        <p:spPr>
          <a:xfrm rot="16200000">
            <a:off x="1543121" y="1721034"/>
            <a:ext cx="12834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ull-length</a:t>
            </a:r>
          </a:p>
        </p:txBody>
      </p:sp>
      <p:sp>
        <p:nvSpPr>
          <p:cNvPr id="53" name="TextBox 52"/>
          <p:cNvSpPr txBox="1"/>
          <p:nvPr/>
        </p:nvSpPr>
        <p:spPr>
          <a:xfrm rot="16200000">
            <a:off x="1747183" y="1672749"/>
            <a:ext cx="15014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HA domain</a:t>
            </a:r>
          </a:p>
        </p:txBody>
      </p:sp>
      <p:sp>
        <p:nvSpPr>
          <p:cNvPr id="54" name="TextBox 53"/>
          <p:cNvSpPr txBox="1"/>
          <p:nvPr/>
        </p:nvSpPr>
        <p:spPr>
          <a:xfrm rot="16200000">
            <a:off x="1676894" y="1238230"/>
            <a:ext cx="23849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hosphatase domain</a:t>
            </a:r>
          </a:p>
        </p:txBody>
      </p:sp>
      <p:sp>
        <p:nvSpPr>
          <p:cNvPr id="55" name="TextBox 54"/>
          <p:cNvSpPr txBox="1"/>
          <p:nvPr/>
        </p:nvSpPr>
        <p:spPr>
          <a:xfrm rot="16200000">
            <a:off x="2305135" y="1563878"/>
            <a:ext cx="1740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Kinase domain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1713821" y="5826103"/>
            <a:ext cx="18401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TXN3-Q29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2115148" y="4043201"/>
            <a:ext cx="10375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ropped</a:t>
            </a:r>
          </a:p>
        </p:txBody>
      </p:sp>
      <p:cxnSp>
        <p:nvCxnSpPr>
          <p:cNvPr id="18" name="Straight Arrow Connector 17"/>
          <p:cNvCxnSpPr/>
          <p:nvPr/>
        </p:nvCxnSpPr>
        <p:spPr>
          <a:xfrm>
            <a:off x="580931" y="3721522"/>
            <a:ext cx="7239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/>
          <p:cNvCxnSpPr/>
          <p:nvPr/>
        </p:nvCxnSpPr>
        <p:spPr>
          <a:xfrm>
            <a:off x="580931" y="3931072"/>
            <a:ext cx="7239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/>
          <p:cNvCxnSpPr/>
          <p:nvPr/>
        </p:nvCxnSpPr>
        <p:spPr>
          <a:xfrm>
            <a:off x="571406" y="4264447"/>
            <a:ext cx="7239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8926" y="2526352"/>
            <a:ext cx="6223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KDa</a:t>
            </a:r>
            <a:endParaRPr lang="en-US" dirty="0"/>
          </a:p>
        </p:txBody>
      </p:sp>
      <p:sp>
        <p:nvSpPr>
          <p:cNvPr id="60" name="TextBox 59"/>
          <p:cNvSpPr txBox="1"/>
          <p:nvPr/>
        </p:nvSpPr>
        <p:spPr>
          <a:xfrm>
            <a:off x="37054" y="3514163"/>
            <a:ext cx="6223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00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119621" y="3772509"/>
            <a:ext cx="6223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5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119621" y="4084936"/>
            <a:ext cx="6223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50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213601" y="6137069"/>
            <a:ext cx="23404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robed with ATXN3 </a:t>
            </a:r>
            <a:r>
              <a:rPr lang="en-US" dirty="0" err="1"/>
              <a:t>Ab</a:t>
            </a:r>
            <a:endParaRPr lang="en-US" dirty="0"/>
          </a:p>
        </p:txBody>
      </p:sp>
      <p:sp>
        <p:nvSpPr>
          <p:cNvPr id="35" name="TextBox 34"/>
          <p:cNvSpPr txBox="1"/>
          <p:nvPr/>
        </p:nvSpPr>
        <p:spPr>
          <a:xfrm>
            <a:off x="4947554" y="4376374"/>
            <a:ext cx="233146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ATXN3-Q72 </a:t>
            </a:r>
          </a:p>
          <a:p>
            <a:pPr algn="ctr"/>
            <a:r>
              <a:rPr lang="en-US" dirty="0"/>
              <a:t>Probed with ATXN3 </a:t>
            </a:r>
            <a:r>
              <a:rPr lang="en-US" dirty="0" err="1"/>
              <a:t>Ab</a:t>
            </a:r>
            <a:endParaRPr lang="en-US" dirty="0"/>
          </a:p>
        </p:txBody>
      </p:sp>
      <p:sp>
        <p:nvSpPr>
          <p:cNvPr id="38" name="TextBox 37"/>
          <p:cNvSpPr txBox="1"/>
          <p:nvPr/>
        </p:nvSpPr>
        <p:spPr>
          <a:xfrm rot="16200000">
            <a:off x="8774997" y="1786475"/>
            <a:ext cx="8096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ST</a:t>
            </a:r>
          </a:p>
        </p:txBody>
      </p:sp>
      <p:sp>
        <p:nvSpPr>
          <p:cNvPr id="39" name="TextBox 38"/>
          <p:cNvSpPr txBox="1"/>
          <p:nvPr/>
        </p:nvSpPr>
        <p:spPr>
          <a:xfrm rot="16200000">
            <a:off x="8960037" y="1544295"/>
            <a:ext cx="12834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ull-length</a:t>
            </a:r>
          </a:p>
        </p:txBody>
      </p:sp>
      <p:sp>
        <p:nvSpPr>
          <p:cNvPr id="40" name="TextBox 39"/>
          <p:cNvSpPr txBox="1"/>
          <p:nvPr/>
        </p:nvSpPr>
        <p:spPr>
          <a:xfrm rot="16200000">
            <a:off x="9694890" y="1435287"/>
            <a:ext cx="15014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HA domain</a:t>
            </a:r>
          </a:p>
        </p:txBody>
      </p:sp>
      <p:sp>
        <p:nvSpPr>
          <p:cNvPr id="42" name="TextBox 41"/>
          <p:cNvSpPr txBox="1"/>
          <p:nvPr/>
        </p:nvSpPr>
        <p:spPr>
          <a:xfrm rot="16200000">
            <a:off x="9636985" y="968432"/>
            <a:ext cx="23849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hosphatase domain</a:t>
            </a:r>
          </a:p>
        </p:txBody>
      </p:sp>
      <p:sp>
        <p:nvSpPr>
          <p:cNvPr id="45" name="TextBox 44"/>
          <p:cNvSpPr txBox="1"/>
          <p:nvPr/>
        </p:nvSpPr>
        <p:spPr>
          <a:xfrm rot="16200000">
            <a:off x="10357458" y="1270814"/>
            <a:ext cx="1740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Kinase domain</a:t>
            </a:r>
          </a:p>
        </p:txBody>
      </p:sp>
      <p:cxnSp>
        <p:nvCxnSpPr>
          <p:cNvPr id="47" name="Straight Arrow Connector 46"/>
          <p:cNvCxnSpPr/>
          <p:nvPr/>
        </p:nvCxnSpPr>
        <p:spPr>
          <a:xfrm>
            <a:off x="8077036" y="3238368"/>
            <a:ext cx="43815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/>
          <p:cNvCxnSpPr/>
          <p:nvPr/>
        </p:nvCxnSpPr>
        <p:spPr>
          <a:xfrm>
            <a:off x="8077030" y="3500703"/>
            <a:ext cx="43815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Arrow Connector 48"/>
          <p:cNvCxnSpPr/>
          <p:nvPr/>
        </p:nvCxnSpPr>
        <p:spPr>
          <a:xfrm>
            <a:off x="8077036" y="3723293"/>
            <a:ext cx="43815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49"/>
          <p:cNvCxnSpPr/>
          <p:nvPr/>
        </p:nvCxnSpPr>
        <p:spPr>
          <a:xfrm>
            <a:off x="8088781" y="4009458"/>
            <a:ext cx="43815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>
            <a:off x="7684188" y="3065913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5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7684188" y="3353961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50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7703882" y="3575590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37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7674145" y="3835142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25</a:t>
            </a:r>
          </a:p>
        </p:txBody>
      </p:sp>
      <p:sp>
        <p:nvSpPr>
          <p:cNvPr id="67" name="TextBox 66"/>
          <p:cNvSpPr txBox="1"/>
          <p:nvPr/>
        </p:nvSpPr>
        <p:spPr>
          <a:xfrm>
            <a:off x="7582364" y="2396323"/>
            <a:ext cx="563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KDa</a:t>
            </a:r>
            <a:endParaRPr lang="en-US" dirty="0"/>
          </a:p>
        </p:txBody>
      </p:sp>
      <p:pic>
        <p:nvPicPr>
          <p:cNvPr id="68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56669" y="2589019"/>
            <a:ext cx="2970260" cy="2181225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9" name="TextBox 68"/>
          <p:cNvSpPr txBox="1"/>
          <p:nvPr/>
        </p:nvSpPr>
        <p:spPr>
          <a:xfrm>
            <a:off x="8826567" y="2257109"/>
            <a:ext cx="25808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   1      2              3     4     5</a:t>
            </a:r>
          </a:p>
        </p:txBody>
      </p:sp>
      <p:sp>
        <p:nvSpPr>
          <p:cNvPr id="76" name="Rectangle 75"/>
          <p:cNvSpPr/>
          <p:nvPr/>
        </p:nvSpPr>
        <p:spPr>
          <a:xfrm>
            <a:off x="8556668" y="2573414"/>
            <a:ext cx="1226491" cy="21968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" name="Rectangle 76"/>
          <p:cNvSpPr/>
          <p:nvPr/>
        </p:nvSpPr>
        <p:spPr>
          <a:xfrm>
            <a:off x="10234604" y="2573414"/>
            <a:ext cx="1292325" cy="21968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9" name="TextBox 78"/>
          <p:cNvSpPr txBox="1"/>
          <p:nvPr/>
        </p:nvSpPr>
        <p:spPr>
          <a:xfrm>
            <a:off x="8866423" y="5549104"/>
            <a:ext cx="250113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GST-PNKP domains (Coomassie stained gel)</a:t>
            </a:r>
          </a:p>
        </p:txBody>
      </p:sp>
      <p:sp>
        <p:nvSpPr>
          <p:cNvPr id="80" name="TextBox 79"/>
          <p:cNvSpPr txBox="1"/>
          <p:nvPr/>
        </p:nvSpPr>
        <p:spPr>
          <a:xfrm>
            <a:off x="9769427" y="4411820"/>
            <a:ext cx="9830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ut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4"/>
          <a:srcRect l="5128" t="42391" r="10256"/>
          <a:stretch/>
        </p:blipFill>
        <p:spPr>
          <a:xfrm flipH="1">
            <a:off x="4914900" y="3257550"/>
            <a:ext cx="2514600" cy="1009650"/>
          </a:xfrm>
          <a:prstGeom prst="rect">
            <a:avLst/>
          </a:prstGeom>
        </p:spPr>
      </p:pic>
      <p:sp>
        <p:nvSpPr>
          <p:cNvPr id="33" name="Rectangle 32"/>
          <p:cNvSpPr/>
          <p:nvPr/>
        </p:nvSpPr>
        <p:spPr>
          <a:xfrm>
            <a:off x="5358159" y="3641254"/>
            <a:ext cx="1847705" cy="45225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" name="TextBox 64"/>
          <p:cNvSpPr txBox="1"/>
          <p:nvPr/>
        </p:nvSpPr>
        <p:spPr>
          <a:xfrm>
            <a:off x="5366412" y="2886941"/>
            <a:ext cx="25431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     2    3    4    5</a:t>
            </a:r>
          </a:p>
        </p:txBody>
      </p:sp>
      <p:sp>
        <p:nvSpPr>
          <p:cNvPr id="66" name="TextBox 65"/>
          <p:cNvSpPr txBox="1"/>
          <p:nvPr/>
        </p:nvSpPr>
        <p:spPr>
          <a:xfrm rot="16200000">
            <a:off x="5131019" y="2329520"/>
            <a:ext cx="8096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ST</a:t>
            </a:r>
          </a:p>
        </p:txBody>
      </p:sp>
      <p:sp>
        <p:nvSpPr>
          <p:cNvPr id="70" name="TextBox 69"/>
          <p:cNvSpPr txBox="1"/>
          <p:nvPr/>
        </p:nvSpPr>
        <p:spPr>
          <a:xfrm rot="16200000">
            <a:off x="5274374" y="2122825"/>
            <a:ext cx="12834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ull-length</a:t>
            </a:r>
          </a:p>
        </p:txBody>
      </p:sp>
      <p:sp>
        <p:nvSpPr>
          <p:cNvPr id="71" name="TextBox 70"/>
          <p:cNvSpPr txBox="1"/>
          <p:nvPr/>
        </p:nvSpPr>
        <p:spPr>
          <a:xfrm rot="16200000">
            <a:off x="5487295" y="2045477"/>
            <a:ext cx="15014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HA domain</a:t>
            </a:r>
          </a:p>
        </p:txBody>
      </p:sp>
      <p:sp>
        <p:nvSpPr>
          <p:cNvPr id="72" name="TextBox 71"/>
          <p:cNvSpPr txBox="1"/>
          <p:nvPr/>
        </p:nvSpPr>
        <p:spPr>
          <a:xfrm rot="16200000">
            <a:off x="5378001" y="1628755"/>
            <a:ext cx="23849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hosphatase domain</a:t>
            </a:r>
          </a:p>
        </p:txBody>
      </p:sp>
      <p:sp>
        <p:nvSpPr>
          <p:cNvPr id="73" name="TextBox 72"/>
          <p:cNvSpPr txBox="1"/>
          <p:nvPr/>
        </p:nvSpPr>
        <p:spPr>
          <a:xfrm rot="16200000">
            <a:off x="6014007" y="1946891"/>
            <a:ext cx="1740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Kinase domain</a:t>
            </a:r>
          </a:p>
        </p:txBody>
      </p:sp>
      <p:cxnSp>
        <p:nvCxnSpPr>
          <p:cNvPr id="74" name="Straight Arrow Connector 73"/>
          <p:cNvCxnSpPr/>
          <p:nvPr/>
        </p:nvCxnSpPr>
        <p:spPr>
          <a:xfrm>
            <a:off x="4628986" y="3419343"/>
            <a:ext cx="43815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Arrow Connector 74"/>
          <p:cNvCxnSpPr/>
          <p:nvPr/>
        </p:nvCxnSpPr>
        <p:spPr>
          <a:xfrm>
            <a:off x="4628980" y="3615003"/>
            <a:ext cx="43815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Arrow Connector 77"/>
          <p:cNvCxnSpPr/>
          <p:nvPr/>
        </p:nvCxnSpPr>
        <p:spPr>
          <a:xfrm>
            <a:off x="4628986" y="3818543"/>
            <a:ext cx="43815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TextBox 80"/>
          <p:cNvSpPr txBox="1"/>
          <p:nvPr/>
        </p:nvSpPr>
        <p:spPr>
          <a:xfrm>
            <a:off x="4161927" y="3246888"/>
            <a:ext cx="5314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250</a:t>
            </a:r>
          </a:p>
        </p:txBody>
      </p:sp>
      <p:sp>
        <p:nvSpPr>
          <p:cNvPr id="82" name="TextBox 81"/>
          <p:cNvSpPr txBox="1"/>
          <p:nvPr/>
        </p:nvSpPr>
        <p:spPr>
          <a:xfrm>
            <a:off x="4136319" y="3468261"/>
            <a:ext cx="5570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50</a:t>
            </a:r>
          </a:p>
        </p:txBody>
      </p:sp>
      <p:sp>
        <p:nvSpPr>
          <p:cNvPr id="83" name="TextBox 82"/>
          <p:cNvSpPr txBox="1"/>
          <p:nvPr/>
        </p:nvSpPr>
        <p:spPr>
          <a:xfrm>
            <a:off x="4152402" y="3659264"/>
            <a:ext cx="5314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00</a:t>
            </a:r>
          </a:p>
        </p:txBody>
      </p:sp>
      <p:sp>
        <p:nvSpPr>
          <p:cNvPr id="84" name="TextBox 83"/>
          <p:cNvSpPr txBox="1"/>
          <p:nvPr/>
        </p:nvSpPr>
        <p:spPr>
          <a:xfrm>
            <a:off x="4183308" y="2650247"/>
            <a:ext cx="6223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KDa</a:t>
            </a:r>
            <a:endParaRPr lang="en-US" dirty="0"/>
          </a:p>
        </p:txBody>
      </p:sp>
      <p:sp>
        <p:nvSpPr>
          <p:cNvPr id="34" name="TextBox 33"/>
          <p:cNvSpPr txBox="1"/>
          <p:nvPr/>
        </p:nvSpPr>
        <p:spPr>
          <a:xfrm>
            <a:off x="6072668" y="3984713"/>
            <a:ext cx="10375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ropped</a:t>
            </a:r>
          </a:p>
        </p:txBody>
      </p:sp>
      <p:cxnSp>
        <p:nvCxnSpPr>
          <p:cNvPr id="8" name="Straight Connector 7"/>
          <p:cNvCxnSpPr/>
          <p:nvPr/>
        </p:nvCxnSpPr>
        <p:spPr>
          <a:xfrm>
            <a:off x="9179809" y="4771972"/>
            <a:ext cx="0" cy="36933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Connector 84"/>
          <p:cNvCxnSpPr/>
          <p:nvPr/>
        </p:nvCxnSpPr>
        <p:spPr>
          <a:xfrm>
            <a:off x="10808584" y="4781497"/>
            <a:ext cx="0" cy="36933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9179809" y="5131779"/>
            <a:ext cx="421930" cy="95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Connector 85"/>
          <p:cNvCxnSpPr/>
          <p:nvPr/>
        </p:nvCxnSpPr>
        <p:spPr>
          <a:xfrm>
            <a:off x="10432041" y="5141304"/>
            <a:ext cx="37937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9601739" y="4974542"/>
            <a:ext cx="8303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joined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659422" y="1479432"/>
            <a:ext cx="3620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87" name="TextBox 86"/>
          <p:cNvSpPr txBox="1"/>
          <p:nvPr/>
        </p:nvSpPr>
        <p:spPr>
          <a:xfrm>
            <a:off x="4265373" y="1422896"/>
            <a:ext cx="3620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88" name="TextBox 87"/>
          <p:cNvSpPr txBox="1"/>
          <p:nvPr/>
        </p:nvSpPr>
        <p:spPr>
          <a:xfrm>
            <a:off x="8267696" y="1358921"/>
            <a:ext cx="3620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cxnSp>
        <p:nvCxnSpPr>
          <p:cNvPr id="89" name="Straight Arrow Connector 88"/>
          <p:cNvCxnSpPr/>
          <p:nvPr/>
        </p:nvCxnSpPr>
        <p:spPr>
          <a:xfrm>
            <a:off x="4619014" y="3988035"/>
            <a:ext cx="43815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TextBox 89"/>
          <p:cNvSpPr txBox="1"/>
          <p:nvPr/>
        </p:nvSpPr>
        <p:spPr>
          <a:xfrm>
            <a:off x="4247262" y="3828756"/>
            <a:ext cx="5291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5</a:t>
            </a:r>
          </a:p>
        </p:txBody>
      </p:sp>
    </p:spTree>
    <p:extLst>
      <p:ext uri="{BB962C8B-B14F-4D97-AF65-F5344CB8AC3E}">
        <p14:creationId xmlns:p14="http://schemas.microsoft.com/office/powerpoint/2010/main" val="30020769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Roxo">
      <a:dk1>
        <a:sysClr val="windowText" lastClr="000000"/>
      </a:dk1>
      <a:lt1>
        <a:sysClr val="window" lastClr="FFFFFF"/>
      </a:lt1>
      <a:dk2>
        <a:srgbClr val="373545"/>
      </a:dk2>
      <a:lt2>
        <a:srgbClr val="DCD8DC"/>
      </a:lt2>
      <a:accent1>
        <a:srgbClr val="AD84C6"/>
      </a:accent1>
      <a:accent2>
        <a:srgbClr val="8784C7"/>
      </a:accent2>
      <a:accent3>
        <a:srgbClr val="5D739A"/>
      </a:accent3>
      <a:accent4>
        <a:srgbClr val="6997AF"/>
      </a:accent4>
      <a:accent5>
        <a:srgbClr val="84ACB6"/>
      </a:accent5>
      <a:accent6>
        <a:srgbClr val="6F8183"/>
      </a:accent6>
      <a:hlink>
        <a:srgbClr val="69A020"/>
      </a:hlink>
      <a:folHlink>
        <a:srgbClr val="8C8C8C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68</TotalTime>
  <Words>86</Words>
  <Application>Microsoft Office PowerPoint</Application>
  <PresentationFormat>Widescreen</PresentationFormat>
  <Paragraphs>4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ana Sofia da Silva Correia</dc:creator>
  <cp:lastModifiedBy>Chakraborty, Anirban</cp:lastModifiedBy>
  <cp:revision>150</cp:revision>
  <cp:lastPrinted>2023-08-29T23:30:28Z</cp:lastPrinted>
  <dcterms:created xsi:type="dcterms:W3CDTF">2021-02-24T12:59:59Z</dcterms:created>
  <dcterms:modified xsi:type="dcterms:W3CDTF">2023-09-19T13:40:37Z</dcterms:modified>
</cp:coreProperties>
</file>